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98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BD3E1-6326-EAEA-AA4E-CB5664E984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D0526-7E61-4955-C031-9EA89C7562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F2C1E-38EC-8B8A-A7BE-EC040CC8A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AADFBC-C91F-5CBC-54B3-4C658984D5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52583A-2352-4C78-86BB-774E98FFE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85378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EE30B9-C040-132F-A1C4-8172C28003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03955B-6253-0D82-33E2-EDD1B7AB28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9A5B06-6F2A-5AE5-BE9C-DD07ECCCD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EE445-1621-FBC9-E792-43D760986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2369B8-D6CE-27EA-7498-70B34AE5C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1657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F880743-1CFB-AC71-338B-581B6772AD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10A6E-5332-4B08-0A1D-0DC9340D06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1D51BD-84B4-7976-24EC-094010A8F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331B07-82A2-E942-D06E-FFC5B0D4C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AF6A76-8A1F-0688-EE6F-2078EAFE5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5551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F3E397-79D5-30F9-A8C0-F3B86E15F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9610C1-7A98-BF48-A2AF-683559E1A8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00C6C2-AA6B-EB49-2583-64B6A950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DCBB0F-A3C7-9429-880E-1FC64B195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791E40-FF26-D932-0EF5-9DDB64776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42211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3D8DF-71DA-8218-28D6-E7EC6AE785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B982E-D9EE-5835-E4D2-350C5DAE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7E71C-5258-791B-3B64-E2B907D76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4F21D1-DCBC-169D-670B-397A75146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D0D0E-E25F-538C-3CED-F7DB0DF35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40480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48F06-69FF-335F-695D-069C1F7E31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8A1050-E907-ECD8-155C-B94F545117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3AD79C-6A2F-E8B2-F807-B0ADDE505B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77B32F-B922-FC4C-493F-BEAC65115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B2302-3A20-03B8-4459-5A6B28CCCE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B91015-9DED-EFBE-5779-FCAC1CB78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486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F1416-A4CA-1D91-A003-DD2AAF4356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432463-0B34-A737-65BB-F6FCAC0A3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113B73-E643-3092-50C9-836C9273E4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A147ECC-A451-466E-6ECB-1BE0B4500B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076EE5-C818-67D0-7AAB-5F69949C86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D4E11F5-A3FB-42D9-A9D0-EFE909521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0E7305-6858-DBEE-881F-76F2350B1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975E74-89A1-F5D2-9C87-2D7AC19DD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21310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4F422E-8E1D-99B9-8B97-615EF683F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240BCA1-6E04-5962-505B-0E17E5405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16ACF3-E789-0CEA-3936-FD252725E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920E13-E437-C9B0-D852-7871D0942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36095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46A43E-DC2B-F021-58DF-61A3C4743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57B6230-23B2-2C7D-EF85-43A070D264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6D0EF5-46BD-D13C-40C4-DAFB822B6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08934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EBB53-9C26-4294-175C-1D460F48F7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03EC4A-5007-1117-DB6C-A6FDF0C19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B1829-202B-854C-33F2-199B1F8804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DE4F7-D23B-5599-8F0A-7F2F10EF1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2A92CD-7C91-D174-09C5-DCC96EDDC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A75C27-6ECB-2D3D-5FF3-899FB7237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124071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417BF-3F53-8031-0BAB-23C8DE041D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9C1DF2B-D017-650A-D31A-5C0EA89939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728D31-D4E1-C75A-3FC7-5C3FD85F9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2918E-FA99-6637-6D5E-D507AFDC5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834CCB-EB1E-B7C4-EC23-60CCAECD9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CC1839-D199-4C5B-37FF-3EA45899E8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55112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A7C2DD5-AC70-7812-5B43-692C6DB307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DDEA4D-A887-84F0-E009-C3EDB043B3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6AF1-DFBC-6713-64CB-66907C7F6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798F8-2CE4-4F87-821B-A024D7FBDFE3}" type="datetimeFigureOut">
              <a:rPr lang="en-DE" smtClean="0"/>
              <a:t>15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A10548-7A20-B0AA-D96C-22CF5C01CC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8D20B0-C719-0828-4564-ACEF025D2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A6BFC4-6FB4-4113-83CC-E19BDEB064B7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285805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8718B1C-ABB3-46CE-AE6A-C2CF6481ACC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447" t="-252" r="12171" b="50766"/>
          <a:stretch/>
        </p:blipFill>
        <p:spPr bwMode="auto">
          <a:xfrm>
            <a:off x="4210760" y="3603363"/>
            <a:ext cx="4482191" cy="2578724"/>
          </a:xfrm>
          <a:prstGeom prst="rect">
            <a:avLst/>
          </a:prstGeom>
          <a:ln>
            <a:noFill/>
          </a:ln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81600B42-4887-48B7-BD4C-6820F364804E}"/>
              </a:ext>
            </a:extLst>
          </p:cNvPr>
          <p:cNvSpPr/>
          <p:nvPr/>
        </p:nvSpPr>
        <p:spPr>
          <a:xfrm>
            <a:off x="4662589" y="4041157"/>
            <a:ext cx="3060000" cy="24110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1DE792-B824-49B7-8DEB-DD4E12D8302E}"/>
              </a:ext>
            </a:extLst>
          </p:cNvPr>
          <p:cNvSpPr txBox="1"/>
          <p:nvPr/>
        </p:nvSpPr>
        <p:spPr>
          <a:xfrm>
            <a:off x="7918380" y="4023089"/>
            <a:ext cx="7745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P8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E491FFA-7B74-B8B0-A2AB-9283ACD6F3F4}"/>
              </a:ext>
            </a:extLst>
          </p:cNvPr>
          <p:cNvSpPr txBox="1"/>
          <p:nvPr/>
        </p:nvSpPr>
        <p:spPr>
          <a:xfrm>
            <a:off x="998926" y="103101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3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FB13A77-2061-5195-68BF-B9CE22BB3256}"/>
              </a:ext>
            </a:extLst>
          </p:cNvPr>
          <p:cNvSpPr txBox="1"/>
          <p:nvPr/>
        </p:nvSpPr>
        <p:spPr>
          <a:xfrm rot="16200000">
            <a:off x="4715832" y="2872581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6E84EE-D271-A482-4040-66CDC2C6A7EA}"/>
              </a:ext>
            </a:extLst>
          </p:cNvPr>
          <p:cNvSpPr txBox="1"/>
          <p:nvPr/>
        </p:nvSpPr>
        <p:spPr>
          <a:xfrm rot="16200000">
            <a:off x="5353489" y="1662843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5E86CE4-5DD4-721E-3734-46C86A010B73}"/>
              </a:ext>
            </a:extLst>
          </p:cNvPr>
          <p:cNvSpPr txBox="1"/>
          <p:nvPr/>
        </p:nvSpPr>
        <p:spPr>
          <a:xfrm rot="16200000">
            <a:off x="4893949" y="2583960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9146EF-286F-98A5-34D7-3C79C358A79B}"/>
              </a:ext>
            </a:extLst>
          </p:cNvPr>
          <p:cNvSpPr txBox="1"/>
          <p:nvPr/>
        </p:nvSpPr>
        <p:spPr>
          <a:xfrm rot="16200000">
            <a:off x="5653238" y="2463586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81B1B58-2003-335F-26A7-62B1F3A45D16}"/>
              </a:ext>
            </a:extLst>
          </p:cNvPr>
          <p:cNvSpPr txBox="1"/>
          <p:nvPr/>
        </p:nvSpPr>
        <p:spPr>
          <a:xfrm rot="16200000">
            <a:off x="5371627" y="2636710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BC2F436-2822-1F87-5545-B9B1BCCB2635}"/>
              </a:ext>
            </a:extLst>
          </p:cNvPr>
          <p:cNvSpPr txBox="1"/>
          <p:nvPr/>
        </p:nvSpPr>
        <p:spPr>
          <a:xfrm rot="16200000">
            <a:off x="5814335" y="1709100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5DDCD93-7B4D-5841-2B46-9D9D2DDD48D7}"/>
              </a:ext>
            </a:extLst>
          </p:cNvPr>
          <p:cNvCxnSpPr>
            <a:cxnSpLocks/>
          </p:cNvCxnSpPr>
          <p:nvPr/>
        </p:nvCxnSpPr>
        <p:spPr>
          <a:xfrm>
            <a:off x="4736525" y="321659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46D68FC-2121-724A-6BD5-1FBA8EF35884}"/>
              </a:ext>
            </a:extLst>
          </p:cNvPr>
          <p:cNvCxnSpPr>
            <a:cxnSpLocks/>
          </p:cNvCxnSpPr>
          <p:nvPr/>
        </p:nvCxnSpPr>
        <p:spPr>
          <a:xfrm>
            <a:off x="5200351" y="3216594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F899E46-C27F-B86E-91AA-F9E844893869}"/>
              </a:ext>
            </a:extLst>
          </p:cNvPr>
          <p:cNvCxnSpPr>
            <a:cxnSpLocks/>
          </p:cNvCxnSpPr>
          <p:nvPr/>
        </p:nvCxnSpPr>
        <p:spPr>
          <a:xfrm>
            <a:off x="5661196" y="32163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69263F56-5F8A-5CC2-3FED-8A5C4AE8E553}"/>
              </a:ext>
            </a:extLst>
          </p:cNvPr>
          <p:cNvCxnSpPr>
            <a:cxnSpLocks/>
          </p:cNvCxnSpPr>
          <p:nvPr/>
        </p:nvCxnSpPr>
        <p:spPr>
          <a:xfrm>
            <a:off x="6115676" y="32163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962DEC08-AD43-19E2-0B15-C3A5C3C3778F}"/>
              </a:ext>
            </a:extLst>
          </p:cNvPr>
          <p:cNvCxnSpPr>
            <a:cxnSpLocks/>
          </p:cNvCxnSpPr>
          <p:nvPr/>
        </p:nvCxnSpPr>
        <p:spPr>
          <a:xfrm>
            <a:off x="6565325" y="321876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282584F5-A6C3-86CC-C689-2C4145AF14A6}"/>
              </a:ext>
            </a:extLst>
          </p:cNvPr>
          <p:cNvCxnSpPr>
            <a:cxnSpLocks/>
          </p:cNvCxnSpPr>
          <p:nvPr/>
        </p:nvCxnSpPr>
        <p:spPr>
          <a:xfrm>
            <a:off x="7022525" y="321634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3BDDBD33-461C-377B-980D-920C0602C05C}"/>
              </a:ext>
            </a:extLst>
          </p:cNvPr>
          <p:cNvSpPr txBox="1"/>
          <p:nvPr/>
        </p:nvSpPr>
        <p:spPr>
          <a:xfrm>
            <a:off x="4146285" y="325226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C62670E-BEF5-5674-C738-E1425083E6A5}"/>
              </a:ext>
            </a:extLst>
          </p:cNvPr>
          <p:cNvSpPr txBox="1"/>
          <p:nvPr/>
        </p:nvSpPr>
        <p:spPr>
          <a:xfrm>
            <a:off x="3765480" y="3531730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34F4EC4-80C2-C02A-319C-97DFDCDC1CD4}"/>
              </a:ext>
            </a:extLst>
          </p:cNvPr>
          <p:cNvSpPr txBox="1"/>
          <p:nvPr/>
        </p:nvSpPr>
        <p:spPr>
          <a:xfrm>
            <a:off x="4671920" y="3235537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D4620A6-E347-44F8-5F5C-614769FB0DD1}"/>
              </a:ext>
            </a:extLst>
          </p:cNvPr>
          <p:cNvSpPr txBox="1"/>
          <p:nvPr/>
        </p:nvSpPr>
        <p:spPr>
          <a:xfrm>
            <a:off x="4671920" y="3484923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A574FFF-A551-4641-88C5-9C3206A05EE2}"/>
              </a:ext>
            </a:extLst>
          </p:cNvPr>
          <p:cNvCxnSpPr>
            <a:cxnSpLocks/>
          </p:cNvCxnSpPr>
          <p:nvPr/>
        </p:nvCxnSpPr>
        <p:spPr>
          <a:xfrm>
            <a:off x="4286373" y="4449671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36">
            <a:extLst>
              <a:ext uri="{FF2B5EF4-FFF2-40B4-BE49-F238E27FC236}">
                <a16:creationId xmlns:a16="http://schemas.microsoft.com/office/drawing/2014/main" id="{B6D0D383-1505-487F-82B9-B59E6F78A4FF}"/>
              </a:ext>
            </a:extLst>
          </p:cNvPr>
          <p:cNvSpPr txBox="1"/>
          <p:nvPr/>
        </p:nvSpPr>
        <p:spPr>
          <a:xfrm>
            <a:off x="3957987" y="43076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9B40CB1-81A9-45A0-B4CD-F5B29B9AF4E7}"/>
              </a:ext>
            </a:extLst>
          </p:cNvPr>
          <p:cNvCxnSpPr>
            <a:cxnSpLocks/>
          </p:cNvCxnSpPr>
          <p:nvPr/>
        </p:nvCxnSpPr>
        <p:spPr>
          <a:xfrm>
            <a:off x="4288187" y="4659088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8">
            <a:extLst>
              <a:ext uri="{FF2B5EF4-FFF2-40B4-BE49-F238E27FC236}">
                <a16:creationId xmlns:a16="http://schemas.microsoft.com/office/drawing/2014/main" id="{1F2CDE62-3CD6-4FD1-BF2A-3EF20FAFD791}"/>
              </a:ext>
            </a:extLst>
          </p:cNvPr>
          <p:cNvSpPr txBox="1"/>
          <p:nvPr/>
        </p:nvSpPr>
        <p:spPr>
          <a:xfrm>
            <a:off x="3959801" y="451701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9EAF9DA-BF25-41EE-8C51-075774D50D8A}"/>
              </a:ext>
            </a:extLst>
          </p:cNvPr>
          <p:cNvCxnSpPr>
            <a:cxnSpLocks/>
          </p:cNvCxnSpPr>
          <p:nvPr/>
        </p:nvCxnSpPr>
        <p:spPr>
          <a:xfrm>
            <a:off x="4287656" y="4175535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40">
            <a:extLst>
              <a:ext uri="{FF2B5EF4-FFF2-40B4-BE49-F238E27FC236}">
                <a16:creationId xmlns:a16="http://schemas.microsoft.com/office/drawing/2014/main" id="{70309426-856D-4AA9-A0E1-A64FA23EA01F}"/>
              </a:ext>
            </a:extLst>
          </p:cNvPr>
          <p:cNvSpPr txBox="1"/>
          <p:nvPr/>
        </p:nvSpPr>
        <p:spPr>
          <a:xfrm>
            <a:off x="3959270" y="403346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564853D1-D2AA-4555-9232-8F4B30CE5274}"/>
              </a:ext>
            </a:extLst>
          </p:cNvPr>
          <p:cNvCxnSpPr>
            <a:cxnSpLocks/>
          </p:cNvCxnSpPr>
          <p:nvPr/>
        </p:nvCxnSpPr>
        <p:spPr>
          <a:xfrm>
            <a:off x="4286182" y="400324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2">
            <a:extLst>
              <a:ext uri="{FF2B5EF4-FFF2-40B4-BE49-F238E27FC236}">
                <a16:creationId xmlns:a16="http://schemas.microsoft.com/office/drawing/2014/main" id="{44A5D88D-F615-4853-BFC0-329F609A7F01}"/>
              </a:ext>
            </a:extLst>
          </p:cNvPr>
          <p:cNvSpPr txBox="1"/>
          <p:nvPr/>
        </p:nvSpPr>
        <p:spPr>
          <a:xfrm>
            <a:off x="3957796" y="385440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ED009B97-457D-4873-A180-87F76ED0D6D6}"/>
              </a:ext>
            </a:extLst>
          </p:cNvPr>
          <p:cNvCxnSpPr>
            <a:cxnSpLocks/>
          </p:cNvCxnSpPr>
          <p:nvPr/>
        </p:nvCxnSpPr>
        <p:spPr>
          <a:xfrm>
            <a:off x="4286373" y="5164006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8">
            <a:extLst>
              <a:ext uri="{FF2B5EF4-FFF2-40B4-BE49-F238E27FC236}">
                <a16:creationId xmlns:a16="http://schemas.microsoft.com/office/drawing/2014/main" id="{F43B81AB-3B63-411F-8B44-CF7662B6A8A3}"/>
              </a:ext>
            </a:extLst>
          </p:cNvPr>
          <p:cNvSpPr txBox="1"/>
          <p:nvPr/>
        </p:nvSpPr>
        <p:spPr>
          <a:xfrm>
            <a:off x="3957987" y="502193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7941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9</cp:revision>
  <dcterms:created xsi:type="dcterms:W3CDTF">2024-08-13T14:46:47Z</dcterms:created>
  <dcterms:modified xsi:type="dcterms:W3CDTF">2024-08-14T22:08:43Z</dcterms:modified>
</cp:coreProperties>
</file>